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3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272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982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1083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7897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2255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957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9838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145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744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5250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2240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48B5EE-9E8B-45C6-90D0-7AF9FCEFBF3A}" type="datetimeFigureOut">
              <a:rPr kumimoji="1" lang="ja-JP" altLang="en-US" smtClean="0"/>
              <a:t>2020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D85A8-ABE4-46F5-9B6A-C2EE19078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585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261475" y="437883"/>
            <a:ext cx="16690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Century" panose="02040604050505020304" pitchFamily="18" charset="0"/>
              </a:rPr>
              <a:t>Supplement 1</a:t>
            </a:r>
            <a:endParaRPr kumimoji="1" lang="ja-JP" altLang="en-US" dirty="0">
              <a:latin typeface="Century" panose="020406040505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2185" y="1455312"/>
            <a:ext cx="6607631" cy="4200779"/>
          </a:xfrm>
          <a:prstGeom prst="rect">
            <a:avLst/>
          </a:prstGeom>
        </p:spPr>
      </p:pic>
      <p:cxnSp>
        <p:nvCxnSpPr>
          <p:cNvPr id="7" name="直線矢印コネクタ 6"/>
          <p:cNvCxnSpPr/>
          <p:nvPr/>
        </p:nvCxnSpPr>
        <p:spPr>
          <a:xfrm>
            <a:off x="3065172" y="2640169"/>
            <a:ext cx="386366" cy="425003"/>
          </a:xfrm>
          <a:prstGeom prst="straightConnector1">
            <a:avLst/>
          </a:prstGeom>
          <a:ln w="762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7242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5178121" y="437883"/>
            <a:ext cx="1835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Century" panose="02040604050505020304" pitchFamily="18" charset="0"/>
              </a:rPr>
              <a:t>Supplement 2A</a:t>
            </a:r>
            <a:endParaRPr kumimoji="1" lang="ja-JP" altLang="en-US" dirty="0">
              <a:latin typeface="Century" panose="02040604050505020304" pitchFamily="18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563" y="1468192"/>
            <a:ext cx="6890139" cy="4214005"/>
          </a:xfrm>
          <a:prstGeom prst="rect">
            <a:avLst/>
          </a:prstGeom>
        </p:spPr>
      </p:pic>
      <p:cxnSp>
        <p:nvCxnSpPr>
          <p:cNvPr id="4" name="直線矢印コネクタ 3"/>
          <p:cNvCxnSpPr/>
          <p:nvPr/>
        </p:nvCxnSpPr>
        <p:spPr>
          <a:xfrm>
            <a:off x="2871989" y="2374367"/>
            <a:ext cx="399245" cy="334851"/>
          </a:xfrm>
          <a:prstGeom prst="straightConnector1">
            <a:avLst/>
          </a:prstGeom>
          <a:ln w="762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3708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5178121" y="437883"/>
            <a:ext cx="1835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Century" panose="02040604050505020304" pitchFamily="18" charset="0"/>
              </a:rPr>
              <a:t>Supplement 2B</a:t>
            </a:r>
            <a:endParaRPr kumimoji="1" lang="ja-JP" altLang="en-US" dirty="0">
              <a:latin typeface="Century" panose="02040604050505020304" pitchFamily="18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563" y="1468192"/>
            <a:ext cx="6870397" cy="4214005"/>
          </a:xfrm>
          <a:prstGeom prst="rect">
            <a:avLst/>
          </a:prstGeom>
        </p:spPr>
      </p:pic>
      <p:cxnSp>
        <p:nvCxnSpPr>
          <p:cNvPr id="4" name="直線矢印コネクタ 3"/>
          <p:cNvCxnSpPr/>
          <p:nvPr/>
        </p:nvCxnSpPr>
        <p:spPr>
          <a:xfrm rot="10800000" flipH="1" flipV="1">
            <a:off x="3026396" y="2367926"/>
            <a:ext cx="399245" cy="334851"/>
          </a:xfrm>
          <a:prstGeom prst="straightConnector1">
            <a:avLst/>
          </a:prstGeom>
          <a:ln w="762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矢印コネクタ 4"/>
          <p:cNvCxnSpPr/>
          <p:nvPr/>
        </p:nvCxnSpPr>
        <p:spPr>
          <a:xfrm rot="10800000" flipH="1" flipV="1">
            <a:off x="3567904" y="2384141"/>
            <a:ext cx="399245" cy="334851"/>
          </a:xfrm>
          <a:prstGeom prst="straightConnector1">
            <a:avLst/>
          </a:prstGeom>
          <a:ln w="762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54828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0473376"/>
              </p:ext>
            </p:extLst>
          </p:nvPr>
        </p:nvGraphicFramePr>
        <p:xfrm>
          <a:off x="347731" y="724367"/>
          <a:ext cx="11281892" cy="600028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99581"/>
                <a:gridCol w="1160282"/>
                <a:gridCol w="3078051"/>
                <a:gridCol w="965916"/>
                <a:gridCol w="1674253"/>
                <a:gridCol w="3103809"/>
              </a:tblGrid>
              <a:tr h="237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IHC marker</a:t>
                      </a:r>
                      <a:endParaRPr lang="de-DE" sz="1400" b="1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Dilution</a:t>
                      </a:r>
                      <a:endParaRPr lang="de-DE" sz="1400" b="1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Company</a:t>
                      </a:r>
                      <a:endParaRPr lang="de-DE" sz="1400" b="1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Country</a:t>
                      </a:r>
                      <a:endParaRPr lang="de-DE" sz="1400" b="1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Catalog number</a:t>
                      </a:r>
                      <a:endParaRPr lang="de-DE" sz="1400" b="1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ositive marker</a:t>
                      </a:r>
                      <a:endParaRPr lang="de-DE" sz="1400" b="1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456032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BMP-2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×20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GI(Proteintehc Group, Inc.) Proteintech Japa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Japa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66383-1-IG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osteoblast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237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Osteonecti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×5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Haematologic Technologies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AON-5031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osteoblast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237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Osteocalci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×20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Takar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Japa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MO-44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osteoblast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456032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Cytokeratin AE1/AE3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×20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Leica biosystems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A0094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intestinal epithelium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237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TGF-</a:t>
                      </a:r>
                      <a:r>
                        <a:rPr lang="el-GR" sz="1400" u="none" strike="noStrike">
                          <a:effectLst/>
                        </a:rPr>
                        <a:t>β1</a:t>
                      </a:r>
                      <a:endParaRPr lang="el-GR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×10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Santa Cruz Biotechnology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sc-146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megakaryocyte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237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Gli2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×20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LifeSpan Biosciences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LS-132808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epiderm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237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Smad 2/3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×5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Santa Cruz Biotechnology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sc-11769-R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endometrium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237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nesti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×10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Abcam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Japa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ab105389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GIST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237000">
                <a:tc>
                  <a:txBody>
                    <a:bodyPr/>
                    <a:lstStyle/>
                    <a:p>
                      <a:pPr algn="l" fontAlgn="ctr"/>
                      <a:r>
                        <a:rPr lang="el-GR" sz="1400" u="none" strike="noStrike">
                          <a:effectLst/>
                        </a:rPr>
                        <a:t>α-</a:t>
                      </a:r>
                      <a:r>
                        <a:rPr lang="de-DE" sz="1400" u="none" strike="noStrike">
                          <a:effectLst/>
                        </a:rPr>
                        <a:t>SM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×5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Dako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Japa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M851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smooth muscle cell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456032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CK7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 dirty="0">
                          <a:effectLst/>
                        </a:rPr>
                        <a:t>Ready to use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Nichirei Corporatio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Japa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413481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alveolar epithelium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456032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D2-40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Ready to use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Nichirei Corporatio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Japa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</a:rPr>
                        <a:t>413451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 dirty="0">
                          <a:effectLst/>
                        </a:rPr>
                        <a:t>lymphatic endothelium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456032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Chromogranin 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Ready to use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Leica biosystems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A0430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</a:rPr>
                        <a:t>neuroendocrine cell of intestinal trac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456032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Synaptophysin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Ready to use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Leica biosystems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A0299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</a:rPr>
                        <a:t>neuroendocrine cell of peripheral nerve and  intestinal trac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456032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CD56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Ready to use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Leica biosystems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A0191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eripheral nerve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456032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CD68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Ready to use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Leica biosystems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A0273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macrophage and monocyte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  <a:tr h="456032"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CDX2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Ready to use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Leica biosystems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USA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>
                          <a:effectLst/>
                        </a:rPr>
                        <a:t>PA0375</a:t>
                      </a:r>
                      <a:endParaRPr lang="de-DE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400" u="none" strike="noStrike" dirty="0">
                          <a:effectLst/>
                        </a:rPr>
                        <a:t>intestinal epithelium (nucleus)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785" marR="7785" marT="7785" marB="0" anchor="ctr"/>
                </a:tc>
              </a:tr>
            </a:tbl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5154153" y="49797"/>
            <a:ext cx="16690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Century" panose="02040604050505020304" pitchFamily="18" charset="0"/>
              </a:rPr>
              <a:t>Supplement 3</a:t>
            </a:r>
            <a:endParaRPr kumimoji="1" lang="ja-JP" altLang="en-US" dirty="0">
              <a:latin typeface="Century" panose="02040604050505020304" pitchFamily="18" charset="0"/>
            </a:endParaRPr>
          </a:p>
        </p:txBody>
      </p:sp>
      <p:cxnSp>
        <p:nvCxnSpPr>
          <p:cNvPr id="5" name="直線コネクタ 4"/>
          <p:cNvCxnSpPr/>
          <p:nvPr/>
        </p:nvCxnSpPr>
        <p:spPr>
          <a:xfrm>
            <a:off x="347731" y="724366"/>
            <a:ext cx="1128189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>
            <a:off x="347731" y="965510"/>
            <a:ext cx="1128189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347731" y="6724655"/>
            <a:ext cx="1128189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3559892" y="361324"/>
            <a:ext cx="5072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Century" panose="02040604050505020304" pitchFamily="18" charset="0"/>
              </a:rPr>
              <a:t>Details of antibodies used in </a:t>
            </a:r>
            <a:r>
              <a:rPr kumimoji="1" lang="en-US" altLang="ja-JP" dirty="0" smtClean="0">
                <a:latin typeface="Century" panose="02040604050505020304" pitchFamily="18" charset="0"/>
              </a:rPr>
              <a:t>the present case </a:t>
            </a:r>
            <a:endParaRPr kumimoji="1" lang="ja-JP" altLang="en-US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44017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5261476" y="244700"/>
            <a:ext cx="16690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Century" panose="02040604050505020304" pitchFamily="18" charset="0"/>
              </a:rPr>
              <a:t>Supplement 4</a:t>
            </a:r>
            <a:endParaRPr kumimoji="1" lang="ja-JP" altLang="en-US" dirty="0">
              <a:latin typeface="Century" panose="02040604050505020304" pitchFamily="18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334851" y="1007920"/>
            <a:ext cx="11230377" cy="56938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ocedure: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raffin section was </a:t>
            </a:r>
            <a:r>
              <a:rPr lang="en-US" altLang="ja-JP" sz="1400" kern="100" dirty="0" err="1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affined</a:t>
            </a: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y Clear</a:t>
            </a:r>
            <a:r>
              <a:rPr lang="ja-JP" altLang="en-US" sz="1400" kern="100" dirty="0"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 smtClean="0"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lus</a:t>
            </a:r>
            <a:r>
              <a:rPr lang="en-US" altLang="ja-JP" sz="1400" kern="100" dirty="0" smtClean="0">
                <a:solidFill>
                  <a:srgbClr val="FF0000"/>
                </a:solidFill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Substitute for xylene)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tigen retrieval; Place paraffin-embedded slides in Antigen Retrieval Buffer  (</a:t>
            </a:r>
            <a:r>
              <a:rPr lang="en-US" altLang="ja-JP" sz="1400" kern="100" dirty="0" err="1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is</a:t>
            </a: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EDTA Buffer, pH 9.0),  cover with a vented plastic wrap, place in microwave and set high power to boil and then set low power to keep it boiling for 10 min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ash 2x2 minutes with PBS-Tween 20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ormal Serum Blocking: Without washing, incubate sections directly with normal goat serum blocking solution for 30 minutes at room temperature. 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ash 3x2 minutes with PBS-Tween 20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ndogenous Peroxidase Blocking: Incubate sections with 3% H2O2 in PBS for 10 minutes to block endogenous peroxidase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ash 3x2 minutes with PBS-Tween 20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ndogenous Mouse IgG Blocking: Incubate sections with Unconjugated </a:t>
            </a:r>
            <a:r>
              <a:rPr lang="en-US" altLang="ja-JP" sz="1400" kern="100" dirty="0" err="1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ffiniPure</a:t>
            </a: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ab Fragment Goat Anti-Mouse IgG (H+L) (Jackson </a:t>
            </a:r>
            <a:r>
              <a:rPr lang="en-US" altLang="ja-JP" sz="1400" kern="100" dirty="0" err="1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munoResearch</a:t>
            </a: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Labs, Code Number: 115-007-003) for 1 hour at room temperature. 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ash 3x2 minutes with PBS-Tween 20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ti BMP-2 antibody; Incubate sections with primary antibody at X200 dilution in primary antibody dilution buffer for 30 minutes at room temperature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ash 2x2 minutes with PBS-Tween 20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econdary Antibody: Incubate sections with </a:t>
            </a:r>
            <a:r>
              <a:rPr lang="en-US" altLang="ja-JP" sz="1400" kern="100" dirty="0" err="1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stofine</a:t>
            </a: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imple Stain MAX PO (Nichirei Corp., Tokyo, Japan) for 30 min at room temperature. 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ash 3x2 minutes with PBS-Tween 20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romogen Substrate: Incubate sections with DAB for 5 minutes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ash with tap water briefly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unterstain with hematoxylin as desired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inse with tap water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hydrate through 95% and 100% ethanol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lear with xylene.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 algn="just">
              <a:spcAft>
                <a:spcPts val="0"/>
              </a:spcAft>
              <a:buFont typeface="+mj-lt"/>
              <a:buAutoNum type="arabicPeriod"/>
            </a:pPr>
            <a:r>
              <a:rPr lang="en-US" altLang="ja-JP" sz="1400" kern="100" dirty="0" smtClean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verslip with permanent mounting medium.</a:t>
            </a:r>
            <a:endParaRPr lang="ja-JP" altLang="ja-JP" sz="1400" kern="100" dirty="0">
              <a:effectLst/>
              <a:latin typeface="Century" panose="020406040505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115857" y="614032"/>
            <a:ext cx="5960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Century" panose="02040604050505020304" pitchFamily="18" charset="0"/>
              </a:rPr>
              <a:t>The </a:t>
            </a:r>
            <a:r>
              <a:rPr lang="en-US" altLang="ja-JP" dirty="0" smtClean="0">
                <a:latin typeface="Century" panose="02040604050505020304" pitchFamily="18" charset="0"/>
              </a:rPr>
              <a:t>immunostaining </a:t>
            </a:r>
            <a:r>
              <a:rPr kumimoji="1" lang="en-US" altLang="ja-JP" dirty="0" smtClean="0">
                <a:latin typeface="Century" panose="02040604050505020304" pitchFamily="18" charset="0"/>
              </a:rPr>
              <a:t>protocol used in the present case</a:t>
            </a:r>
            <a:endParaRPr kumimoji="1" lang="ja-JP" altLang="en-US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6806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</TotalTime>
  <Words>478</Words>
  <Application>Microsoft Office PowerPoint</Application>
  <PresentationFormat>ワイド画面</PresentationFormat>
  <Paragraphs>130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3" baseType="lpstr">
      <vt:lpstr>ＭＳ Ｐゴシック</vt:lpstr>
      <vt:lpstr>游明朝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永野 秀樹</dc:creator>
  <cp:lastModifiedBy>永野 秀樹</cp:lastModifiedBy>
  <cp:revision>14</cp:revision>
  <dcterms:created xsi:type="dcterms:W3CDTF">2020-10-06T12:00:11Z</dcterms:created>
  <dcterms:modified xsi:type="dcterms:W3CDTF">2020-10-15T11:56:21Z</dcterms:modified>
</cp:coreProperties>
</file>